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76" r:id="rId1"/>
  </p:sldMasterIdLst>
  <p:notesMasterIdLst>
    <p:notesMasterId r:id="rId7"/>
  </p:notesMasterIdLst>
  <p:sldIdLst>
    <p:sldId id="312" r:id="rId2"/>
    <p:sldId id="313" r:id="rId3"/>
    <p:sldId id="317" r:id="rId4"/>
    <p:sldId id="314" r:id="rId5"/>
    <p:sldId id="316" r:id="rId6"/>
  </p:sldIdLst>
  <p:sldSz cx="6400800" cy="9144000"/>
  <p:notesSz cx="6950075" cy="92360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236D6"/>
    <a:srgbClr val="F8766D"/>
    <a:srgbClr val="57FBFF"/>
    <a:srgbClr val="FF3300"/>
    <a:srgbClr val="1A9696"/>
    <a:srgbClr val="CCFFFF"/>
    <a:srgbClr val="CCFFCC"/>
    <a:srgbClr val="FFCCFF"/>
    <a:srgbClr val="CC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775DCB02-9BB8-47FD-8907-85C794F793BA}" styleName="Themed Style 1 - Accent 4">
    <a:tblBg>
      <a:fillRef idx="2">
        <a:schemeClr val="accent4"/>
      </a:fillRef>
      <a:effectRef idx="1">
        <a:schemeClr val="accent4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Ref idx="1">
              <a:schemeClr val="accent4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  <a:fill>
          <a:solidFill>
            <a:schemeClr val="accent4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4"/>
            </a:lnRef>
          </a:left>
          <a:right>
            <a:lnRef idx="2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2">
              <a:schemeClr val="accent4"/>
            </a:lnRef>
          </a:top>
          <a:bottom>
            <a:lnRef idx="2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4"/>
          </a:solidFill>
        </a:fill>
      </a:tcStyle>
    </a:firstRow>
  </a:tblStyle>
  <a:tblStyle styleId="{C4B1156A-380E-4F78-BDF5-A606A8083BF9}" styleName="Medium Style 4 - Accent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 w="12700" cmpd="sng">
              <a:solidFill>
                <a:schemeClr val="accent4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4"/>
              </a:solidFill>
            </a:ln>
          </a:top>
        </a:tcBdr>
        <a:fill>
          <a:solidFill>
            <a:schemeClr val="accent4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4">
              <a:tint val="20000"/>
            </a:schemeClr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510" autoAdjust="0"/>
    <p:restoredTop sz="95226" autoAdjust="0"/>
  </p:normalViewPr>
  <p:slideViewPr>
    <p:cSldViewPr snapToGrid="0">
      <p:cViewPr varScale="1">
        <p:scale>
          <a:sx n="61" d="100"/>
          <a:sy n="61" d="100"/>
        </p:scale>
        <p:origin x="2558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as, Jayanta (NIH/NIA/IRP) [F]" userId="3243943d-e18f-4960-837a-4764bf53c7a5" providerId="ADAL" clId="{BB41EF35-59AB-4831-99DE-84A50738065C}"/>
    <pc:docChg chg="modSld">
      <pc:chgData name="Das, Jayanta (NIH/NIA/IRP) [F]" userId="3243943d-e18f-4960-837a-4764bf53c7a5" providerId="ADAL" clId="{BB41EF35-59AB-4831-99DE-84A50738065C}" dt="2023-08-16T16:51:54.105" v="35" actId="14100"/>
      <pc:docMkLst>
        <pc:docMk/>
      </pc:docMkLst>
      <pc:sldChg chg="modSp mod">
        <pc:chgData name="Das, Jayanta (NIH/NIA/IRP) [F]" userId="3243943d-e18f-4960-837a-4764bf53c7a5" providerId="ADAL" clId="{BB41EF35-59AB-4831-99DE-84A50738065C}" dt="2023-08-16T16:50:45.436" v="16" actId="113"/>
        <pc:sldMkLst>
          <pc:docMk/>
          <pc:sldMk cId="2433824175" sldId="312"/>
        </pc:sldMkLst>
        <pc:spChg chg="mod">
          <ac:chgData name="Das, Jayanta (NIH/NIA/IRP) [F]" userId="3243943d-e18f-4960-837a-4764bf53c7a5" providerId="ADAL" clId="{BB41EF35-59AB-4831-99DE-84A50738065C}" dt="2023-08-16T16:50:45.436" v="16" actId="113"/>
          <ac:spMkLst>
            <pc:docMk/>
            <pc:sldMk cId="2433824175" sldId="312"/>
            <ac:spMk id="22" creationId="{A4D9DF97-9075-4C95-AE1F-3DDE480310A8}"/>
          </ac:spMkLst>
        </pc:spChg>
        <pc:spChg chg="mod">
          <ac:chgData name="Das, Jayanta (NIH/NIA/IRP) [F]" userId="3243943d-e18f-4960-837a-4764bf53c7a5" providerId="ADAL" clId="{BB41EF35-59AB-4831-99DE-84A50738065C}" dt="2023-08-16T16:50:21.588" v="4" actId="14100"/>
          <ac:spMkLst>
            <pc:docMk/>
            <pc:sldMk cId="2433824175" sldId="312"/>
            <ac:spMk id="33" creationId="{8B8859D6-3CBC-49DB-A431-FC9D6F9C9162}"/>
          </ac:spMkLst>
        </pc:spChg>
        <pc:spChg chg="mod">
          <ac:chgData name="Das, Jayanta (NIH/NIA/IRP) [F]" userId="3243943d-e18f-4960-837a-4764bf53c7a5" providerId="ADAL" clId="{BB41EF35-59AB-4831-99DE-84A50738065C}" dt="2023-08-16T16:50:29.321" v="9" actId="14100"/>
          <ac:spMkLst>
            <pc:docMk/>
            <pc:sldMk cId="2433824175" sldId="312"/>
            <ac:spMk id="35" creationId="{F25BB91C-407A-4652-A32D-DD9DAC959B41}"/>
          </ac:spMkLst>
        </pc:spChg>
      </pc:sldChg>
      <pc:sldChg chg="modSp mod">
        <pc:chgData name="Das, Jayanta (NIH/NIA/IRP) [F]" userId="3243943d-e18f-4960-837a-4764bf53c7a5" providerId="ADAL" clId="{BB41EF35-59AB-4831-99DE-84A50738065C}" dt="2023-08-16T16:51:54.105" v="35" actId="14100"/>
        <pc:sldMkLst>
          <pc:docMk/>
          <pc:sldMk cId="3021254790" sldId="313"/>
        </pc:sldMkLst>
        <pc:spChg chg="mod">
          <ac:chgData name="Das, Jayanta (NIH/NIA/IRP) [F]" userId="3243943d-e18f-4960-837a-4764bf53c7a5" providerId="ADAL" clId="{BB41EF35-59AB-4831-99DE-84A50738065C}" dt="2023-08-16T16:51:07.219" v="25" actId="113"/>
          <ac:spMkLst>
            <pc:docMk/>
            <pc:sldMk cId="3021254790" sldId="313"/>
            <ac:spMk id="39" creationId="{DF958925-505D-5865-8F53-59444A68AD60}"/>
          </ac:spMkLst>
        </pc:spChg>
        <pc:spChg chg="mod">
          <ac:chgData name="Das, Jayanta (NIH/NIA/IRP) [F]" userId="3243943d-e18f-4960-837a-4764bf53c7a5" providerId="ADAL" clId="{BB41EF35-59AB-4831-99DE-84A50738065C}" dt="2023-08-16T16:51:54.105" v="35" actId="14100"/>
          <ac:spMkLst>
            <pc:docMk/>
            <pc:sldMk cId="3021254790" sldId="313"/>
            <ac:spMk id="40" creationId="{2EE2D8D7-5817-4BB7-AE32-4D958026E18A}"/>
          </ac:spMkLst>
        </pc:spChg>
        <pc:spChg chg="mod">
          <ac:chgData name="Das, Jayanta (NIH/NIA/IRP) [F]" userId="3243943d-e18f-4960-837a-4764bf53c7a5" providerId="ADAL" clId="{BB41EF35-59AB-4831-99DE-84A50738065C}" dt="2023-08-16T16:51:17.577" v="30" actId="14100"/>
          <ac:spMkLst>
            <pc:docMk/>
            <pc:sldMk cId="3021254790" sldId="313"/>
            <ac:spMk id="41" creationId="{417566AC-5E7F-8626-1CBB-EDE3BB7F6D9B}"/>
          </ac:spMkLst>
        </pc:spChg>
      </pc:sldChg>
    </pc:docChg>
  </pc:docChgLst>
  <pc:docChgLst>
    <pc:chgData name="Das, Jayanta (NIH/NIA/IRP) [F]" userId="3243943d-e18f-4960-837a-4764bf53c7a5" providerId="ADAL" clId="{DDF215C9-723F-4967-8D23-FDB9FF5AB484}"/>
    <pc:docChg chg="undo custSel modSld">
      <pc:chgData name="Das, Jayanta (NIH/NIA/IRP) [F]" userId="3243943d-e18f-4960-837a-4764bf53c7a5" providerId="ADAL" clId="{DDF215C9-723F-4967-8D23-FDB9FF5AB484}" dt="2023-07-27T15:00:56.686" v="71" actId="20577"/>
      <pc:docMkLst>
        <pc:docMk/>
      </pc:docMkLst>
      <pc:sldChg chg="modSp mod">
        <pc:chgData name="Das, Jayanta (NIH/NIA/IRP) [F]" userId="3243943d-e18f-4960-837a-4764bf53c7a5" providerId="ADAL" clId="{DDF215C9-723F-4967-8D23-FDB9FF5AB484}" dt="2023-07-27T15:00:56.686" v="71" actId="20577"/>
        <pc:sldMkLst>
          <pc:docMk/>
          <pc:sldMk cId="2807382382" sldId="317"/>
        </pc:sldMkLst>
        <pc:spChg chg="mod">
          <ac:chgData name="Das, Jayanta (NIH/NIA/IRP) [F]" userId="3243943d-e18f-4960-837a-4764bf53c7a5" providerId="ADAL" clId="{DDF215C9-723F-4967-8D23-FDB9FF5AB484}" dt="2023-07-27T15:00:56.686" v="71" actId="20577"/>
          <ac:spMkLst>
            <pc:docMk/>
            <pc:sldMk cId="2807382382" sldId="317"/>
            <ac:spMk id="39" creationId="{DF958925-505D-5865-8F53-59444A68AD60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11699" cy="463408"/>
          </a:xfrm>
          <a:prstGeom prst="rect">
            <a:avLst/>
          </a:prstGeom>
        </p:spPr>
        <p:txBody>
          <a:bodyPr vert="horz" lIns="92492" tIns="46246" rIns="92492" bIns="46246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36768" y="0"/>
            <a:ext cx="3011699" cy="463408"/>
          </a:xfrm>
          <a:prstGeom prst="rect">
            <a:avLst/>
          </a:prstGeom>
        </p:spPr>
        <p:txBody>
          <a:bodyPr vert="horz" lIns="92492" tIns="46246" rIns="92492" bIns="46246" rtlCol="0"/>
          <a:lstStyle>
            <a:lvl1pPr algn="r">
              <a:defRPr sz="1200"/>
            </a:lvl1pPr>
          </a:lstStyle>
          <a:p>
            <a:fld id="{B6FEE441-F089-4F3A-8FC1-5CF22887E791}" type="datetimeFigureOut">
              <a:rPr lang="en-US" smtClean="0"/>
              <a:t>8/16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84425" y="1154113"/>
            <a:ext cx="2181225" cy="31178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92" tIns="46246" rIns="92492" bIns="46246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5008" y="4444861"/>
            <a:ext cx="5560060" cy="3636705"/>
          </a:xfrm>
          <a:prstGeom prst="rect">
            <a:avLst/>
          </a:prstGeom>
        </p:spPr>
        <p:txBody>
          <a:bodyPr vert="horz" lIns="92492" tIns="46246" rIns="92492" bIns="46246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772669"/>
            <a:ext cx="3011699" cy="463407"/>
          </a:xfrm>
          <a:prstGeom prst="rect">
            <a:avLst/>
          </a:prstGeom>
        </p:spPr>
        <p:txBody>
          <a:bodyPr vert="horz" lIns="92492" tIns="46246" rIns="92492" bIns="46246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36768" y="8772669"/>
            <a:ext cx="3011699" cy="463407"/>
          </a:xfrm>
          <a:prstGeom prst="rect">
            <a:avLst/>
          </a:prstGeom>
        </p:spPr>
        <p:txBody>
          <a:bodyPr vert="horz" lIns="92492" tIns="46246" rIns="92492" bIns="46246" rtlCol="0" anchor="b"/>
          <a:lstStyle>
            <a:lvl1pPr algn="r">
              <a:defRPr sz="1200"/>
            </a:lvl1pPr>
          </a:lstStyle>
          <a:p>
            <a:fld id="{2318034A-3262-449E-846D-FE8D3B310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51943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33276" rtl="0" eaLnBrk="1" latinLnBrk="0" hangingPunct="1">
      <a:defRPr sz="569" kern="1200">
        <a:solidFill>
          <a:schemeClr val="tx1"/>
        </a:solidFill>
        <a:latin typeface="+mn-lt"/>
        <a:ea typeface="+mn-ea"/>
        <a:cs typeface="+mn-cs"/>
      </a:defRPr>
    </a:lvl1pPr>
    <a:lvl2pPr marL="216638" algn="l" defTabSz="433276" rtl="0" eaLnBrk="1" latinLnBrk="0" hangingPunct="1">
      <a:defRPr sz="569" kern="1200">
        <a:solidFill>
          <a:schemeClr val="tx1"/>
        </a:solidFill>
        <a:latin typeface="+mn-lt"/>
        <a:ea typeface="+mn-ea"/>
        <a:cs typeface="+mn-cs"/>
      </a:defRPr>
    </a:lvl2pPr>
    <a:lvl3pPr marL="433276" algn="l" defTabSz="433276" rtl="0" eaLnBrk="1" latinLnBrk="0" hangingPunct="1">
      <a:defRPr sz="569" kern="1200">
        <a:solidFill>
          <a:schemeClr val="tx1"/>
        </a:solidFill>
        <a:latin typeface="+mn-lt"/>
        <a:ea typeface="+mn-ea"/>
        <a:cs typeface="+mn-cs"/>
      </a:defRPr>
    </a:lvl3pPr>
    <a:lvl4pPr marL="649914" algn="l" defTabSz="433276" rtl="0" eaLnBrk="1" latinLnBrk="0" hangingPunct="1">
      <a:defRPr sz="569" kern="1200">
        <a:solidFill>
          <a:schemeClr val="tx1"/>
        </a:solidFill>
        <a:latin typeface="+mn-lt"/>
        <a:ea typeface="+mn-ea"/>
        <a:cs typeface="+mn-cs"/>
      </a:defRPr>
    </a:lvl4pPr>
    <a:lvl5pPr marL="866552" algn="l" defTabSz="433276" rtl="0" eaLnBrk="1" latinLnBrk="0" hangingPunct="1">
      <a:defRPr sz="569" kern="1200">
        <a:solidFill>
          <a:schemeClr val="tx1"/>
        </a:solidFill>
        <a:latin typeface="+mn-lt"/>
        <a:ea typeface="+mn-ea"/>
        <a:cs typeface="+mn-cs"/>
      </a:defRPr>
    </a:lvl5pPr>
    <a:lvl6pPr marL="1083191" algn="l" defTabSz="433276" rtl="0" eaLnBrk="1" latinLnBrk="0" hangingPunct="1">
      <a:defRPr sz="569" kern="1200">
        <a:solidFill>
          <a:schemeClr val="tx1"/>
        </a:solidFill>
        <a:latin typeface="+mn-lt"/>
        <a:ea typeface="+mn-ea"/>
        <a:cs typeface="+mn-cs"/>
      </a:defRPr>
    </a:lvl6pPr>
    <a:lvl7pPr marL="1299830" algn="l" defTabSz="433276" rtl="0" eaLnBrk="1" latinLnBrk="0" hangingPunct="1">
      <a:defRPr sz="569" kern="1200">
        <a:solidFill>
          <a:schemeClr val="tx1"/>
        </a:solidFill>
        <a:latin typeface="+mn-lt"/>
        <a:ea typeface="+mn-ea"/>
        <a:cs typeface="+mn-cs"/>
      </a:defRPr>
    </a:lvl7pPr>
    <a:lvl8pPr marL="1516468" algn="l" defTabSz="433276" rtl="0" eaLnBrk="1" latinLnBrk="0" hangingPunct="1">
      <a:defRPr sz="569" kern="1200">
        <a:solidFill>
          <a:schemeClr val="tx1"/>
        </a:solidFill>
        <a:latin typeface="+mn-lt"/>
        <a:ea typeface="+mn-ea"/>
        <a:cs typeface="+mn-cs"/>
      </a:defRPr>
    </a:lvl8pPr>
    <a:lvl9pPr marL="1733106" algn="l" defTabSz="433276" rtl="0" eaLnBrk="1" latinLnBrk="0" hangingPunct="1">
      <a:defRPr sz="569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060" y="1496484"/>
            <a:ext cx="5440680" cy="3183467"/>
          </a:xfrm>
        </p:spPr>
        <p:txBody>
          <a:bodyPr anchor="b"/>
          <a:lstStyle>
            <a:lvl1pPr algn="ctr">
              <a:defRPr sz="4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00100" y="4802717"/>
            <a:ext cx="4800600" cy="2207683"/>
          </a:xfrm>
        </p:spPr>
        <p:txBody>
          <a:bodyPr/>
          <a:lstStyle>
            <a:lvl1pPr marL="0" indent="0" algn="ctr">
              <a:buNone/>
              <a:defRPr sz="1680"/>
            </a:lvl1pPr>
            <a:lvl2pPr marL="320040" indent="0" algn="ctr">
              <a:buNone/>
              <a:defRPr sz="1400"/>
            </a:lvl2pPr>
            <a:lvl3pPr marL="640080" indent="0" algn="ctr">
              <a:buNone/>
              <a:defRPr sz="1260"/>
            </a:lvl3pPr>
            <a:lvl4pPr marL="960120" indent="0" algn="ctr">
              <a:buNone/>
              <a:defRPr sz="1120"/>
            </a:lvl4pPr>
            <a:lvl5pPr marL="1280160" indent="0" algn="ctr">
              <a:buNone/>
              <a:defRPr sz="1120"/>
            </a:lvl5pPr>
            <a:lvl6pPr marL="1600200" indent="0" algn="ctr">
              <a:buNone/>
              <a:defRPr sz="1120"/>
            </a:lvl6pPr>
            <a:lvl7pPr marL="1920240" indent="0" algn="ctr">
              <a:buNone/>
              <a:defRPr sz="1120"/>
            </a:lvl7pPr>
            <a:lvl8pPr marL="2240280" indent="0" algn="ctr">
              <a:buNone/>
              <a:defRPr sz="1120"/>
            </a:lvl8pPr>
            <a:lvl9pPr marL="2560320" indent="0" algn="ctr">
              <a:buNone/>
              <a:defRPr sz="11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934A95-8494-454C-B713-2966614CA417}" type="datetimeFigureOut">
              <a:rPr lang="en-US" smtClean="0"/>
              <a:t>8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6A819D-C29B-4732-9AF9-2F61CFE60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68213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934A95-8494-454C-B713-2966614CA417}" type="datetimeFigureOut">
              <a:rPr lang="en-US" smtClean="0"/>
              <a:t>8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6A819D-C29B-4732-9AF9-2F61CFE60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94632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80573" y="486834"/>
            <a:ext cx="1380173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0055" y="486834"/>
            <a:ext cx="4060508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934A95-8494-454C-B713-2966614CA417}" type="datetimeFigureOut">
              <a:rPr lang="en-US" smtClean="0"/>
              <a:t>8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6A819D-C29B-4732-9AF9-2F61CFE60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3881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934A95-8494-454C-B713-2966614CA417}" type="datetimeFigureOut">
              <a:rPr lang="en-US" smtClean="0"/>
              <a:t>8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6A819D-C29B-4732-9AF9-2F61CFE60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09430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6722" y="2279653"/>
            <a:ext cx="5520690" cy="3803649"/>
          </a:xfrm>
        </p:spPr>
        <p:txBody>
          <a:bodyPr anchor="b"/>
          <a:lstStyle>
            <a:lvl1pPr>
              <a:defRPr sz="4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6722" y="6119286"/>
            <a:ext cx="5520690" cy="2000249"/>
          </a:xfrm>
        </p:spPr>
        <p:txBody>
          <a:bodyPr/>
          <a:lstStyle>
            <a:lvl1pPr marL="0" indent="0">
              <a:buNone/>
              <a:defRPr sz="1680">
                <a:solidFill>
                  <a:schemeClr val="tx1"/>
                </a:solidFill>
              </a:defRPr>
            </a:lvl1pPr>
            <a:lvl2pPr marL="32004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2pPr>
            <a:lvl3pPr marL="64008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3pPr>
            <a:lvl4pPr marL="96012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4pPr>
            <a:lvl5pPr marL="128016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5pPr>
            <a:lvl6pPr marL="160020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6pPr>
            <a:lvl7pPr marL="192024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7pPr>
            <a:lvl8pPr marL="224028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8pPr>
            <a:lvl9pPr marL="256032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934A95-8494-454C-B713-2966614CA417}" type="datetimeFigureOut">
              <a:rPr lang="en-US" smtClean="0"/>
              <a:t>8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6A819D-C29B-4732-9AF9-2F61CFE60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56031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0055" y="2434167"/>
            <a:ext cx="272034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40405" y="2434167"/>
            <a:ext cx="272034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934A95-8494-454C-B713-2966614CA417}" type="datetimeFigureOut">
              <a:rPr lang="en-US" smtClean="0"/>
              <a:t>8/1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6A819D-C29B-4732-9AF9-2F61CFE60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86763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486836"/>
            <a:ext cx="5520690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889" y="2241551"/>
            <a:ext cx="2707838" cy="1098549"/>
          </a:xfrm>
        </p:spPr>
        <p:txBody>
          <a:bodyPr anchor="b"/>
          <a:lstStyle>
            <a:lvl1pPr marL="0" indent="0">
              <a:buNone/>
              <a:defRPr sz="1680" b="1"/>
            </a:lvl1pPr>
            <a:lvl2pPr marL="320040" indent="0">
              <a:buNone/>
              <a:defRPr sz="1400" b="1"/>
            </a:lvl2pPr>
            <a:lvl3pPr marL="640080" indent="0">
              <a:buNone/>
              <a:defRPr sz="1260" b="1"/>
            </a:lvl3pPr>
            <a:lvl4pPr marL="960120" indent="0">
              <a:buNone/>
              <a:defRPr sz="1120" b="1"/>
            </a:lvl4pPr>
            <a:lvl5pPr marL="1280160" indent="0">
              <a:buNone/>
              <a:defRPr sz="1120" b="1"/>
            </a:lvl5pPr>
            <a:lvl6pPr marL="1600200" indent="0">
              <a:buNone/>
              <a:defRPr sz="1120" b="1"/>
            </a:lvl6pPr>
            <a:lvl7pPr marL="1920240" indent="0">
              <a:buNone/>
              <a:defRPr sz="1120" b="1"/>
            </a:lvl7pPr>
            <a:lvl8pPr marL="2240280" indent="0">
              <a:buNone/>
              <a:defRPr sz="1120" b="1"/>
            </a:lvl8pPr>
            <a:lvl9pPr marL="2560320" indent="0">
              <a:buNone/>
              <a:defRPr sz="11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0889" y="3340100"/>
            <a:ext cx="2707838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40405" y="2241551"/>
            <a:ext cx="2721174" cy="1098549"/>
          </a:xfrm>
        </p:spPr>
        <p:txBody>
          <a:bodyPr anchor="b"/>
          <a:lstStyle>
            <a:lvl1pPr marL="0" indent="0">
              <a:buNone/>
              <a:defRPr sz="1680" b="1"/>
            </a:lvl1pPr>
            <a:lvl2pPr marL="320040" indent="0">
              <a:buNone/>
              <a:defRPr sz="1400" b="1"/>
            </a:lvl2pPr>
            <a:lvl3pPr marL="640080" indent="0">
              <a:buNone/>
              <a:defRPr sz="1260" b="1"/>
            </a:lvl3pPr>
            <a:lvl4pPr marL="960120" indent="0">
              <a:buNone/>
              <a:defRPr sz="1120" b="1"/>
            </a:lvl4pPr>
            <a:lvl5pPr marL="1280160" indent="0">
              <a:buNone/>
              <a:defRPr sz="1120" b="1"/>
            </a:lvl5pPr>
            <a:lvl6pPr marL="1600200" indent="0">
              <a:buNone/>
              <a:defRPr sz="1120" b="1"/>
            </a:lvl6pPr>
            <a:lvl7pPr marL="1920240" indent="0">
              <a:buNone/>
              <a:defRPr sz="1120" b="1"/>
            </a:lvl7pPr>
            <a:lvl8pPr marL="2240280" indent="0">
              <a:buNone/>
              <a:defRPr sz="1120" b="1"/>
            </a:lvl8pPr>
            <a:lvl9pPr marL="2560320" indent="0">
              <a:buNone/>
              <a:defRPr sz="11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40405" y="3340100"/>
            <a:ext cx="2721174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934A95-8494-454C-B713-2966614CA417}" type="datetimeFigureOut">
              <a:rPr lang="en-US" smtClean="0"/>
              <a:t>8/16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6A819D-C29B-4732-9AF9-2F61CFE60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58852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934A95-8494-454C-B713-2966614CA417}" type="datetimeFigureOut">
              <a:rPr lang="en-US" smtClean="0"/>
              <a:t>8/16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6A819D-C29B-4732-9AF9-2F61CFE60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33545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934A95-8494-454C-B713-2966614CA417}" type="datetimeFigureOut">
              <a:rPr lang="en-US" smtClean="0"/>
              <a:t>8/16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6A819D-C29B-4732-9AF9-2F61CFE60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54113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609600"/>
            <a:ext cx="2064425" cy="2133600"/>
          </a:xfrm>
        </p:spPr>
        <p:txBody>
          <a:bodyPr anchor="b"/>
          <a:lstStyle>
            <a:lvl1pPr>
              <a:defRPr sz="22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21174" y="1316569"/>
            <a:ext cx="3240405" cy="6498167"/>
          </a:xfrm>
        </p:spPr>
        <p:txBody>
          <a:bodyPr/>
          <a:lstStyle>
            <a:lvl1pPr>
              <a:defRPr sz="2240"/>
            </a:lvl1pPr>
            <a:lvl2pPr>
              <a:defRPr sz="1960"/>
            </a:lvl2pPr>
            <a:lvl3pPr>
              <a:defRPr sz="168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0889" y="2743200"/>
            <a:ext cx="2064425" cy="5082117"/>
          </a:xfrm>
        </p:spPr>
        <p:txBody>
          <a:bodyPr/>
          <a:lstStyle>
            <a:lvl1pPr marL="0" indent="0">
              <a:buNone/>
              <a:defRPr sz="1120"/>
            </a:lvl1pPr>
            <a:lvl2pPr marL="320040" indent="0">
              <a:buNone/>
              <a:defRPr sz="980"/>
            </a:lvl2pPr>
            <a:lvl3pPr marL="640080" indent="0">
              <a:buNone/>
              <a:defRPr sz="840"/>
            </a:lvl3pPr>
            <a:lvl4pPr marL="960120" indent="0">
              <a:buNone/>
              <a:defRPr sz="700"/>
            </a:lvl4pPr>
            <a:lvl5pPr marL="1280160" indent="0">
              <a:buNone/>
              <a:defRPr sz="700"/>
            </a:lvl5pPr>
            <a:lvl6pPr marL="1600200" indent="0">
              <a:buNone/>
              <a:defRPr sz="700"/>
            </a:lvl6pPr>
            <a:lvl7pPr marL="1920240" indent="0">
              <a:buNone/>
              <a:defRPr sz="700"/>
            </a:lvl7pPr>
            <a:lvl8pPr marL="2240280" indent="0">
              <a:buNone/>
              <a:defRPr sz="700"/>
            </a:lvl8pPr>
            <a:lvl9pPr marL="2560320" indent="0">
              <a:buNone/>
              <a:defRPr sz="7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934A95-8494-454C-B713-2966614CA417}" type="datetimeFigureOut">
              <a:rPr lang="en-US" smtClean="0"/>
              <a:t>8/1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6A819D-C29B-4732-9AF9-2F61CFE60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25761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609600"/>
            <a:ext cx="2064425" cy="2133600"/>
          </a:xfrm>
        </p:spPr>
        <p:txBody>
          <a:bodyPr anchor="b"/>
          <a:lstStyle>
            <a:lvl1pPr>
              <a:defRPr sz="22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21174" y="1316569"/>
            <a:ext cx="3240405" cy="6498167"/>
          </a:xfrm>
        </p:spPr>
        <p:txBody>
          <a:bodyPr anchor="t"/>
          <a:lstStyle>
            <a:lvl1pPr marL="0" indent="0">
              <a:buNone/>
              <a:defRPr sz="2240"/>
            </a:lvl1pPr>
            <a:lvl2pPr marL="320040" indent="0">
              <a:buNone/>
              <a:defRPr sz="1960"/>
            </a:lvl2pPr>
            <a:lvl3pPr marL="640080" indent="0">
              <a:buNone/>
              <a:defRPr sz="1680"/>
            </a:lvl3pPr>
            <a:lvl4pPr marL="960120" indent="0">
              <a:buNone/>
              <a:defRPr sz="1400"/>
            </a:lvl4pPr>
            <a:lvl5pPr marL="1280160" indent="0">
              <a:buNone/>
              <a:defRPr sz="1400"/>
            </a:lvl5pPr>
            <a:lvl6pPr marL="1600200" indent="0">
              <a:buNone/>
              <a:defRPr sz="1400"/>
            </a:lvl6pPr>
            <a:lvl7pPr marL="1920240" indent="0">
              <a:buNone/>
              <a:defRPr sz="1400"/>
            </a:lvl7pPr>
            <a:lvl8pPr marL="2240280" indent="0">
              <a:buNone/>
              <a:defRPr sz="1400"/>
            </a:lvl8pPr>
            <a:lvl9pPr marL="2560320" indent="0">
              <a:buNone/>
              <a:defRPr sz="14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0889" y="2743200"/>
            <a:ext cx="2064425" cy="5082117"/>
          </a:xfrm>
        </p:spPr>
        <p:txBody>
          <a:bodyPr/>
          <a:lstStyle>
            <a:lvl1pPr marL="0" indent="0">
              <a:buNone/>
              <a:defRPr sz="1120"/>
            </a:lvl1pPr>
            <a:lvl2pPr marL="320040" indent="0">
              <a:buNone/>
              <a:defRPr sz="980"/>
            </a:lvl2pPr>
            <a:lvl3pPr marL="640080" indent="0">
              <a:buNone/>
              <a:defRPr sz="840"/>
            </a:lvl3pPr>
            <a:lvl4pPr marL="960120" indent="0">
              <a:buNone/>
              <a:defRPr sz="700"/>
            </a:lvl4pPr>
            <a:lvl5pPr marL="1280160" indent="0">
              <a:buNone/>
              <a:defRPr sz="700"/>
            </a:lvl5pPr>
            <a:lvl6pPr marL="1600200" indent="0">
              <a:buNone/>
              <a:defRPr sz="700"/>
            </a:lvl6pPr>
            <a:lvl7pPr marL="1920240" indent="0">
              <a:buNone/>
              <a:defRPr sz="700"/>
            </a:lvl7pPr>
            <a:lvl8pPr marL="2240280" indent="0">
              <a:buNone/>
              <a:defRPr sz="700"/>
            </a:lvl8pPr>
            <a:lvl9pPr marL="2560320" indent="0">
              <a:buNone/>
              <a:defRPr sz="7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934A95-8494-454C-B713-2966614CA417}" type="datetimeFigureOut">
              <a:rPr lang="en-US" smtClean="0"/>
              <a:t>8/1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6A819D-C29B-4732-9AF9-2F61CFE60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30671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0055" y="486836"/>
            <a:ext cx="552069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055" y="2434167"/>
            <a:ext cx="552069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0055" y="8475136"/>
            <a:ext cx="144018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934A95-8494-454C-B713-2966614CA417}" type="datetimeFigureOut">
              <a:rPr lang="en-US" smtClean="0"/>
              <a:t>8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20265" y="8475136"/>
            <a:ext cx="216027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20565" y="8475136"/>
            <a:ext cx="144018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6A819D-C29B-4732-9AF9-2F61CFE60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02342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77" r:id="rId1"/>
    <p:sldLayoutId id="2147483878" r:id="rId2"/>
    <p:sldLayoutId id="2147483879" r:id="rId3"/>
    <p:sldLayoutId id="2147483880" r:id="rId4"/>
    <p:sldLayoutId id="2147483881" r:id="rId5"/>
    <p:sldLayoutId id="2147483882" r:id="rId6"/>
    <p:sldLayoutId id="2147483883" r:id="rId7"/>
    <p:sldLayoutId id="2147483884" r:id="rId8"/>
    <p:sldLayoutId id="2147483885" r:id="rId9"/>
    <p:sldLayoutId id="2147483886" r:id="rId10"/>
    <p:sldLayoutId id="2147483887" r:id="rId11"/>
  </p:sldLayoutIdLst>
  <p:txStyles>
    <p:titleStyle>
      <a:lvl1pPr algn="l" defTabSz="640080" rtl="0" eaLnBrk="1" latinLnBrk="0" hangingPunct="1">
        <a:lnSpc>
          <a:spcPct val="90000"/>
        </a:lnSpc>
        <a:spcBef>
          <a:spcPct val="0"/>
        </a:spcBef>
        <a:buNone/>
        <a:defRPr sz="30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0020" indent="-160020" algn="l" defTabSz="64008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196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2pPr>
      <a:lvl3pPr marL="80010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112014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4pPr>
      <a:lvl5pPr marL="144018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5pPr>
      <a:lvl6pPr marL="176022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6pPr>
      <a:lvl7pPr marL="208026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8pPr>
      <a:lvl9pPr marL="272034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1pPr>
      <a:lvl2pPr marL="32004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2pPr>
      <a:lvl3pPr marL="64008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3pPr>
      <a:lvl4pPr marL="96012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4pPr>
      <a:lvl5pPr marL="128016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5pPr>
      <a:lvl6pPr marL="160020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6pPr>
      <a:lvl7pPr marL="192024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7pPr>
      <a:lvl8pPr marL="224028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8pPr>
      <a:lvl9pPr marL="256032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70048F3F-B8B9-419A-B8C2-28B92831E4A6}"/>
              </a:ext>
            </a:extLst>
          </p:cNvPr>
          <p:cNvGrpSpPr/>
          <p:nvPr/>
        </p:nvGrpSpPr>
        <p:grpSpPr>
          <a:xfrm>
            <a:off x="1648709" y="3467883"/>
            <a:ext cx="3272092" cy="2744639"/>
            <a:chOff x="5256424" y="4988059"/>
            <a:chExt cx="3259661" cy="3687046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02F1F3E7-039F-4DF9-9B32-277231009B0A}"/>
                </a:ext>
              </a:extLst>
            </p:cNvPr>
            <p:cNvGrpSpPr/>
            <p:nvPr/>
          </p:nvGrpSpPr>
          <p:grpSpPr>
            <a:xfrm>
              <a:off x="5256424" y="4988059"/>
              <a:ext cx="3259661" cy="3687046"/>
              <a:chOff x="5816857" y="4183791"/>
              <a:chExt cx="3086405" cy="3418804"/>
            </a:xfrm>
          </p:grpSpPr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6F253C43-5BDD-48E6-9F78-6F252062ABD0}"/>
                  </a:ext>
                </a:extLst>
              </p:cNvPr>
              <p:cNvSpPr txBox="1"/>
              <p:nvPr/>
            </p:nvSpPr>
            <p:spPr>
              <a:xfrm>
                <a:off x="6381170" y="7334231"/>
                <a:ext cx="2034724" cy="2683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lack: total; </a:t>
                </a:r>
                <a:r>
                  <a:rPr lang="en-US" sz="800" b="1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d: </a:t>
                </a:r>
                <a:r>
                  <a: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eta&gt;0; </a:t>
                </a:r>
                <a:r>
                  <a:rPr lang="en-US" sz="800" b="1" dirty="0">
                    <a:solidFill>
                      <a:schemeClr val="accent5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lue: </a:t>
                </a:r>
                <a:r>
                  <a: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eta&lt;0</a:t>
                </a:r>
              </a:p>
            </p:txBody>
          </p:sp>
          <p:grpSp>
            <p:nvGrpSpPr>
              <p:cNvPr id="8" name="Group 7">
                <a:extLst>
                  <a:ext uri="{FF2B5EF4-FFF2-40B4-BE49-F238E27FC236}">
                    <a16:creationId xmlns:a16="http://schemas.microsoft.com/office/drawing/2014/main" id="{34F98DE9-2B3F-46F6-9F91-3D922606B590}"/>
                  </a:ext>
                </a:extLst>
              </p:cNvPr>
              <p:cNvGrpSpPr/>
              <p:nvPr/>
            </p:nvGrpSpPr>
            <p:grpSpPr>
              <a:xfrm>
                <a:off x="5816857" y="4183791"/>
                <a:ext cx="3086405" cy="3079242"/>
                <a:chOff x="5710372" y="4183791"/>
                <a:chExt cx="3086405" cy="3079242"/>
              </a:xfrm>
            </p:grpSpPr>
            <p:grpSp>
              <p:nvGrpSpPr>
                <p:cNvPr id="9" name="Group 8">
                  <a:extLst>
                    <a:ext uri="{FF2B5EF4-FFF2-40B4-BE49-F238E27FC236}">
                      <a16:creationId xmlns:a16="http://schemas.microsoft.com/office/drawing/2014/main" id="{1942CE9B-F55F-4C88-AD38-697B3AC07228}"/>
                    </a:ext>
                  </a:extLst>
                </p:cNvPr>
                <p:cNvGrpSpPr/>
                <p:nvPr/>
              </p:nvGrpSpPr>
              <p:grpSpPr>
                <a:xfrm>
                  <a:off x="5710372" y="4615755"/>
                  <a:ext cx="3086405" cy="2647278"/>
                  <a:chOff x="6279264" y="847862"/>
                  <a:chExt cx="5005153" cy="7967893"/>
                </a:xfrm>
              </p:grpSpPr>
              <p:sp>
                <p:nvSpPr>
                  <p:cNvPr id="12" name="TextBox 11">
                    <a:extLst>
                      <a:ext uri="{FF2B5EF4-FFF2-40B4-BE49-F238E27FC236}">
                        <a16:creationId xmlns:a16="http://schemas.microsoft.com/office/drawing/2014/main" id="{D81BC9A3-C8F9-48C3-AE35-E9FBDAB50316}"/>
                      </a:ext>
                    </a:extLst>
                  </p:cNvPr>
                  <p:cNvSpPr txBox="1"/>
                  <p:nvPr/>
                </p:nvSpPr>
                <p:spPr>
                  <a:xfrm>
                    <a:off x="6279264" y="7473462"/>
                    <a:ext cx="2874664" cy="126929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solidFill>
                          <a:srgbClr val="D236D6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upported 2258 RNAs in the LMM (Baseline and 12 m)</a:t>
                    </a:r>
                  </a:p>
                </p:txBody>
              </p:sp>
              <p:sp>
                <p:nvSpPr>
                  <p:cNvPr id="13" name="TextBox 12">
                    <a:extLst>
                      <a:ext uri="{FF2B5EF4-FFF2-40B4-BE49-F238E27FC236}">
                        <a16:creationId xmlns:a16="http://schemas.microsoft.com/office/drawing/2014/main" id="{FA9F729D-BA39-402F-8F4D-64E43E9E85CB}"/>
                      </a:ext>
                    </a:extLst>
                  </p:cNvPr>
                  <p:cNvSpPr txBox="1"/>
                  <p:nvPr/>
                </p:nvSpPr>
                <p:spPr>
                  <a:xfrm>
                    <a:off x="8844229" y="7546465"/>
                    <a:ext cx="2440188" cy="126929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solidFill>
                          <a:schemeClr val="accent6">
                            <a:lumMod val="7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upported 523 RNAs in the LMM (Baseline and 24 </a:t>
                    </a:r>
                    <a:r>
                      <a:rPr lang="en-US" sz="800" b="1" dirty="0" err="1">
                        <a:solidFill>
                          <a:schemeClr val="accent6">
                            <a:lumMod val="7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mo</a:t>
                    </a:r>
                    <a:r>
                      <a:rPr lang="en-US" sz="800" b="1" dirty="0">
                        <a:solidFill>
                          <a:schemeClr val="accent6">
                            <a:lumMod val="7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)</a:t>
                    </a:r>
                  </a:p>
                </p:txBody>
              </p:sp>
              <p:grpSp>
                <p:nvGrpSpPr>
                  <p:cNvPr id="14" name="Group 13">
                    <a:extLst>
                      <a:ext uri="{FF2B5EF4-FFF2-40B4-BE49-F238E27FC236}">
                        <a16:creationId xmlns:a16="http://schemas.microsoft.com/office/drawing/2014/main" id="{E2E7EEB9-3628-4C19-B16B-E0991829F7C1}"/>
                      </a:ext>
                    </a:extLst>
                  </p:cNvPr>
                  <p:cNvGrpSpPr/>
                  <p:nvPr/>
                </p:nvGrpSpPr>
                <p:grpSpPr>
                  <a:xfrm>
                    <a:off x="6728524" y="847862"/>
                    <a:ext cx="4274564" cy="6691994"/>
                    <a:chOff x="6728524" y="847862"/>
                    <a:chExt cx="4274564" cy="6691994"/>
                  </a:xfrm>
                </p:grpSpPr>
                <p:sp>
                  <p:nvSpPr>
                    <p:cNvPr id="18" name="Freeform: Shape 17">
                      <a:extLst>
                        <a:ext uri="{FF2B5EF4-FFF2-40B4-BE49-F238E27FC236}">
                          <a16:creationId xmlns:a16="http://schemas.microsoft.com/office/drawing/2014/main" id="{37460D1E-B437-4A2E-BDB3-C7DABD02CD6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283789" y="847862"/>
                      <a:ext cx="3120887" cy="5094973"/>
                    </a:xfrm>
                    <a:custGeom>
                      <a:avLst/>
                      <a:gdLst>
                        <a:gd name="connsiteX0" fmla="*/ 0 w 3251200"/>
                        <a:gd name="connsiteY0" fmla="*/ 1625600 h 3251200"/>
                        <a:gd name="connsiteX1" fmla="*/ 1625600 w 3251200"/>
                        <a:gd name="connsiteY1" fmla="*/ 0 h 3251200"/>
                        <a:gd name="connsiteX2" fmla="*/ 3251200 w 3251200"/>
                        <a:gd name="connsiteY2" fmla="*/ 1625600 h 3251200"/>
                        <a:gd name="connsiteX3" fmla="*/ 1625600 w 3251200"/>
                        <a:gd name="connsiteY3" fmla="*/ 3251200 h 3251200"/>
                        <a:gd name="connsiteX4" fmla="*/ 0 w 3251200"/>
                        <a:gd name="connsiteY4" fmla="*/ 1625600 h 3251200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</a:cxnLst>
                      <a:rect l="l" t="t" r="r" b="b"/>
                      <a:pathLst>
                        <a:path w="3251200" h="3251200">
                          <a:moveTo>
                            <a:pt x="0" y="1625600"/>
                          </a:moveTo>
                          <a:cubicBezTo>
                            <a:pt x="0" y="727806"/>
                            <a:pt x="727806" y="0"/>
                            <a:pt x="1625600" y="0"/>
                          </a:cubicBezTo>
                          <a:cubicBezTo>
                            <a:pt x="2523394" y="0"/>
                            <a:pt x="3251200" y="727806"/>
                            <a:pt x="3251200" y="1625600"/>
                          </a:cubicBezTo>
                          <a:cubicBezTo>
                            <a:pt x="3251200" y="2523394"/>
                            <a:pt x="2523394" y="3251200"/>
                            <a:pt x="1625600" y="3251200"/>
                          </a:cubicBezTo>
                          <a:cubicBezTo>
                            <a:pt x="727806" y="3251200"/>
                            <a:pt x="0" y="2523394"/>
                            <a:pt x="0" y="1625600"/>
                          </a:cubicBezTo>
                          <a:close/>
                        </a:path>
                      </a:pathLst>
                    </a:custGeom>
                    <a:solidFill>
                      <a:srgbClr val="FFC000">
                        <a:alpha val="50000"/>
                      </a:srgbClr>
                    </a:solidFill>
                  </p:spPr>
                  <p:style>
                    <a:lnRef idx="2">
                      <a:schemeClr val="lt1">
                        <a:hueOff val="0"/>
                        <a:satOff val="0"/>
                        <a:lumOff val="0"/>
                        <a:alphaOff val="0"/>
                      </a:schemeClr>
                    </a:lnRef>
                    <a:fillRef idx="1">
                      <a:schemeClr val="accent4">
                        <a:alpha val="50000"/>
                        <a:hueOff val="0"/>
                        <a:satOff val="0"/>
                        <a:lumOff val="0"/>
                        <a:alphaOff val="0"/>
                      </a:schemeClr>
                    </a:fillRef>
                    <a:effectRef idx="0">
                      <a:schemeClr val="accent4">
                        <a:alpha val="50000"/>
                        <a:hueOff val="0"/>
                        <a:satOff val="0"/>
                        <a:lumOff val="0"/>
                        <a:alphaOff val="0"/>
                      </a:schemeClr>
                    </a:effectRef>
                    <a:fontRef idx="minor">
                      <a:schemeClr val="tx1"/>
                    </a:fontRef>
                  </p:style>
                  <p:txBody>
                    <a:bodyPr spcFirstLastPara="0" vert="horz" wrap="square" lIns="144941" tIns="190233" rIns="144941" bIns="407644" numCol="1" spcCol="1270" anchor="ctr" anchorCtr="0">
                      <a:noAutofit/>
                    </a:bodyPr>
                    <a:lstStyle/>
                    <a:p>
                      <a:pPr algn="ctr" defTabSz="237780">
                        <a:lnSpc>
                          <a:spcPct val="90000"/>
                        </a:lnSpc>
                        <a:spcBef>
                          <a:spcPct val="0"/>
                        </a:spcBef>
                        <a:spcAft>
                          <a:spcPct val="35000"/>
                        </a:spcAft>
                      </a:pPr>
                      <a:endPara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9" name="Freeform: Shape 18">
                      <a:extLst>
                        <a:ext uri="{FF2B5EF4-FFF2-40B4-BE49-F238E27FC236}">
                          <a16:creationId xmlns:a16="http://schemas.microsoft.com/office/drawing/2014/main" id="{A952B86E-415B-45E5-9906-F72BD3F75F1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8436443" y="3054725"/>
                      <a:ext cx="2566645" cy="4485131"/>
                    </a:xfrm>
                    <a:custGeom>
                      <a:avLst/>
                      <a:gdLst>
                        <a:gd name="connsiteX0" fmla="*/ 0 w 3251200"/>
                        <a:gd name="connsiteY0" fmla="*/ 1625600 h 3251200"/>
                        <a:gd name="connsiteX1" fmla="*/ 1625600 w 3251200"/>
                        <a:gd name="connsiteY1" fmla="*/ 0 h 3251200"/>
                        <a:gd name="connsiteX2" fmla="*/ 3251200 w 3251200"/>
                        <a:gd name="connsiteY2" fmla="*/ 1625600 h 3251200"/>
                        <a:gd name="connsiteX3" fmla="*/ 1625600 w 3251200"/>
                        <a:gd name="connsiteY3" fmla="*/ 3251200 h 3251200"/>
                        <a:gd name="connsiteX4" fmla="*/ 0 w 3251200"/>
                        <a:gd name="connsiteY4" fmla="*/ 1625600 h 3251200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</a:cxnLst>
                      <a:rect l="l" t="t" r="r" b="b"/>
                      <a:pathLst>
                        <a:path w="3251200" h="3251200">
                          <a:moveTo>
                            <a:pt x="0" y="1625600"/>
                          </a:moveTo>
                          <a:cubicBezTo>
                            <a:pt x="0" y="727806"/>
                            <a:pt x="727806" y="0"/>
                            <a:pt x="1625600" y="0"/>
                          </a:cubicBezTo>
                          <a:cubicBezTo>
                            <a:pt x="2523394" y="0"/>
                            <a:pt x="3251200" y="727806"/>
                            <a:pt x="3251200" y="1625600"/>
                          </a:cubicBezTo>
                          <a:cubicBezTo>
                            <a:pt x="3251200" y="2523394"/>
                            <a:pt x="2523394" y="3251200"/>
                            <a:pt x="1625600" y="3251200"/>
                          </a:cubicBezTo>
                          <a:cubicBezTo>
                            <a:pt x="727806" y="3251200"/>
                            <a:pt x="0" y="2523394"/>
                            <a:pt x="0" y="1625600"/>
                          </a:cubicBezTo>
                          <a:close/>
                        </a:path>
                      </a:pathLst>
                    </a:custGeom>
                    <a:solidFill>
                      <a:schemeClr val="accent6">
                        <a:lumMod val="75000"/>
                        <a:alpha val="50000"/>
                      </a:schemeClr>
                    </a:solidFill>
                  </p:spPr>
                  <p:style>
                    <a:lnRef idx="2">
                      <a:schemeClr val="lt1">
                        <a:hueOff val="0"/>
                        <a:satOff val="0"/>
                        <a:lumOff val="0"/>
                        <a:alphaOff val="0"/>
                      </a:schemeClr>
                    </a:lnRef>
                    <a:fillRef idx="1">
                      <a:schemeClr val="accent4">
                        <a:alpha val="50000"/>
                        <a:hueOff val="4900445"/>
                        <a:satOff val="-20388"/>
                        <a:lumOff val="4804"/>
                        <a:alphaOff val="0"/>
                      </a:schemeClr>
                    </a:fillRef>
                    <a:effectRef idx="0">
                      <a:schemeClr val="accent4">
                        <a:alpha val="50000"/>
                        <a:hueOff val="4900445"/>
                        <a:satOff val="-20388"/>
                        <a:lumOff val="4804"/>
                        <a:alphaOff val="0"/>
                      </a:schemeClr>
                    </a:effectRef>
                    <a:fontRef idx="minor">
                      <a:schemeClr val="tx1"/>
                    </a:fontRef>
                  </p:style>
                  <p:txBody>
                    <a:bodyPr spcFirstLastPara="0" vert="horz" wrap="square" lIns="332456" tIns="280821" rIns="102364" bIns="208351" numCol="1" spcCol="1270" anchor="ctr" anchorCtr="0">
                      <a:noAutofit/>
                    </a:bodyPr>
                    <a:lstStyle/>
                    <a:p>
                      <a:pPr algn="ctr" defTabSz="237780">
                        <a:lnSpc>
                          <a:spcPct val="90000"/>
                        </a:lnSpc>
                        <a:spcBef>
                          <a:spcPct val="0"/>
                        </a:spcBef>
                        <a:spcAft>
                          <a:spcPct val="35000"/>
                        </a:spcAft>
                      </a:pPr>
                      <a:endPara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20" name="Freeform: Shape 19">
                      <a:extLst>
                        <a:ext uri="{FF2B5EF4-FFF2-40B4-BE49-F238E27FC236}">
                          <a16:creationId xmlns:a16="http://schemas.microsoft.com/office/drawing/2014/main" id="{EAB83E44-EF35-4B05-BBE4-87DC51A73AA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6728524" y="2952702"/>
                      <a:ext cx="2566646" cy="4583054"/>
                    </a:xfrm>
                    <a:custGeom>
                      <a:avLst/>
                      <a:gdLst>
                        <a:gd name="connsiteX0" fmla="*/ 0 w 3251200"/>
                        <a:gd name="connsiteY0" fmla="*/ 1625600 h 3251200"/>
                        <a:gd name="connsiteX1" fmla="*/ 1625600 w 3251200"/>
                        <a:gd name="connsiteY1" fmla="*/ 0 h 3251200"/>
                        <a:gd name="connsiteX2" fmla="*/ 3251200 w 3251200"/>
                        <a:gd name="connsiteY2" fmla="*/ 1625600 h 3251200"/>
                        <a:gd name="connsiteX3" fmla="*/ 1625600 w 3251200"/>
                        <a:gd name="connsiteY3" fmla="*/ 3251200 h 3251200"/>
                        <a:gd name="connsiteX4" fmla="*/ 0 w 3251200"/>
                        <a:gd name="connsiteY4" fmla="*/ 1625600 h 3251200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</a:cxnLst>
                      <a:rect l="l" t="t" r="r" b="b"/>
                      <a:pathLst>
                        <a:path w="3251200" h="3251200">
                          <a:moveTo>
                            <a:pt x="0" y="1625600"/>
                          </a:moveTo>
                          <a:cubicBezTo>
                            <a:pt x="0" y="727806"/>
                            <a:pt x="727806" y="0"/>
                            <a:pt x="1625600" y="0"/>
                          </a:cubicBezTo>
                          <a:cubicBezTo>
                            <a:pt x="2523394" y="0"/>
                            <a:pt x="3251200" y="727806"/>
                            <a:pt x="3251200" y="1625600"/>
                          </a:cubicBezTo>
                          <a:cubicBezTo>
                            <a:pt x="3251200" y="2523394"/>
                            <a:pt x="2523394" y="3251200"/>
                            <a:pt x="1625600" y="3251200"/>
                          </a:cubicBezTo>
                          <a:cubicBezTo>
                            <a:pt x="727806" y="3251200"/>
                            <a:pt x="0" y="2523394"/>
                            <a:pt x="0" y="1625600"/>
                          </a:cubicBezTo>
                          <a:close/>
                        </a:path>
                      </a:pathLst>
                    </a:custGeom>
                    <a:solidFill>
                      <a:srgbClr val="7030A0">
                        <a:alpha val="50000"/>
                      </a:srgbClr>
                    </a:solidFill>
                  </p:spPr>
                  <p:style>
                    <a:lnRef idx="2">
                      <a:schemeClr val="lt1">
                        <a:hueOff val="0"/>
                        <a:satOff val="0"/>
                        <a:lumOff val="0"/>
                        <a:alphaOff val="0"/>
                      </a:schemeClr>
                    </a:lnRef>
                    <a:fillRef idx="1">
                      <a:schemeClr val="accent4">
                        <a:alpha val="50000"/>
                        <a:hueOff val="9800891"/>
                        <a:satOff val="-40777"/>
                        <a:lumOff val="9608"/>
                        <a:alphaOff val="0"/>
                      </a:schemeClr>
                    </a:fillRef>
                    <a:effectRef idx="0">
                      <a:schemeClr val="accent4">
                        <a:alpha val="50000"/>
                        <a:hueOff val="9800891"/>
                        <a:satOff val="-40777"/>
                        <a:lumOff val="9608"/>
                        <a:alphaOff val="0"/>
                      </a:schemeClr>
                    </a:effectRef>
                    <a:fontRef idx="minor">
                      <a:schemeClr val="tx1"/>
                    </a:fontRef>
                  </p:style>
                  <p:txBody>
                    <a:bodyPr spcFirstLastPara="0" vert="horz" wrap="square" lIns="102364" tIns="280821" rIns="332456" bIns="208351" numCol="1" spcCol="1270" anchor="ctr" anchorCtr="0">
                      <a:noAutofit/>
                    </a:bodyPr>
                    <a:lstStyle/>
                    <a:p>
                      <a:pPr algn="ctr" defTabSz="237780">
                        <a:lnSpc>
                          <a:spcPct val="90000"/>
                        </a:lnSpc>
                        <a:spcBef>
                          <a:spcPct val="0"/>
                        </a:spcBef>
                        <a:spcAft>
                          <a:spcPct val="35000"/>
                        </a:spcAft>
                      </a:pPr>
                      <a:endPara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sp>
                <p:nvSpPr>
                  <p:cNvPr id="15" name="TextBox 14">
                    <a:extLst>
                      <a:ext uri="{FF2B5EF4-FFF2-40B4-BE49-F238E27FC236}">
                        <a16:creationId xmlns:a16="http://schemas.microsoft.com/office/drawing/2014/main" id="{30E7A995-0BDC-4230-AA68-80AC87B7A969}"/>
                      </a:ext>
                    </a:extLst>
                  </p:cNvPr>
                  <p:cNvSpPr txBox="1"/>
                  <p:nvPr/>
                </p:nvSpPr>
                <p:spPr>
                  <a:xfrm>
                    <a:off x="8586945" y="3843851"/>
                    <a:ext cx="557101" cy="173085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13</a:t>
                    </a:r>
                  </a:p>
                  <a:p>
                    <a:r>
                      <a:rPr lang="en-US" sz="800" b="1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75 </a:t>
                    </a:r>
                    <a:endParaRPr lang="en-US" sz="800" b="1" dirty="0">
                      <a:solidFill>
                        <a:srgbClr val="0070C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r>
                      <a:rPr lang="en-US" sz="800" b="1" dirty="0">
                        <a:solidFill>
                          <a:srgbClr val="0070C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38</a:t>
                    </a:r>
                  </a:p>
                </p:txBody>
              </p:sp>
              <p:sp>
                <p:nvSpPr>
                  <p:cNvPr id="16" name="TextBox 15">
                    <a:extLst>
                      <a:ext uri="{FF2B5EF4-FFF2-40B4-BE49-F238E27FC236}">
                        <a16:creationId xmlns:a16="http://schemas.microsoft.com/office/drawing/2014/main" id="{A644ABAF-4F75-4175-BB20-DC21D104E012}"/>
                      </a:ext>
                    </a:extLst>
                  </p:cNvPr>
                  <p:cNvSpPr txBox="1"/>
                  <p:nvPr/>
                </p:nvSpPr>
                <p:spPr>
                  <a:xfrm>
                    <a:off x="7743697" y="3548946"/>
                    <a:ext cx="517869" cy="173085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429</a:t>
                    </a:r>
                  </a:p>
                  <a:p>
                    <a:r>
                      <a:rPr lang="en-US" sz="800" b="1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373</a:t>
                    </a:r>
                    <a:endParaRPr lang="en-US" sz="800" b="1" dirty="0">
                      <a:solidFill>
                        <a:srgbClr val="0070C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r>
                      <a:rPr lang="en-US" sz="800" b="1" dirty="0">
                        <a:solidFill>
                          <a:srgbClr val="0070C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56</a:t>
                    </a:r>
                  </a:p>
                </p:txBody>
              </p:sp>
              <p:sp>
                <p:nvSpPr>
                  <p:cNvPr id="17" name="TextBox 16">
                    <a:extLst>
                      <a:ext uri="{FF2B5EF4-FFF2-40B4-BE49-F238E27FC236}">
                        <a16:creationId xmlns:a16="http://schemas.microsoft.com/office/drawing/2014/main" id="{AC70DFE0-303F-411A-BB65-F2F55B3B3B63}"/>
                      </a:ext>
                    </a:extLst>
                  </p:cNvPr>
                  <p:cNvSpPr txBox="1"/>
                  <p:nvPr/>
                </p:nvSpPr>
                <p:spPr>
                  <a:xfrm>
                    <a:off x="9249808" y="3548549"/>
                    <a:ext cx="517869" cy="173085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29</a:t>
                    </a:r>
                  </a:p>
                  <a:p>
                    <a:r>
                      <a:rPr lang="en-US" sz="800" b="1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56</a:t>
                    </a:r>
                  </a:p>
                  <a:p>
                    <a:r>
                      <a:rPr lang="en-US" sz="800" b="1" dirty="0">
                        <a:solidFill>
                          <a:srgbClr val="0070C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73</a:t>
                    </a:r>
                    <a:endParaRPr lang="en-US" sz="800" b="1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B7E64C1C-03FB-410E-8D49-AD0AAE8FFC3C}"/>
                    </a:ext>
                  </a:extLst>
                </p:cNvPr>
                <p:cNvSpPr txBox="1"/>
                <p:nvPr/>
              </p:nvSpPr>
              <p:spPr>
                <a:xfrm>
                  <a:off x="7155907" y="4833002"/>
                  <a:ext cx="414212" cy="57506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32</a:t>
                  </a:r>
                </a:p>
                <a:p>
                  <a:r>
                    <a:rPr lang="en-US" sz="800" b="1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93</a:t>
                  </a:r>
                </a:p>
                <a:p>
                  <a:r>
                    <a:rPr lang="en-US" sz="800" b="1" dirty="0">
                      <a:solidFill>
                        <a:srgbClr val="0070C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9</a:t>
                  </a:r>
                </a:p>
              </p:txBody>
            </p:sp>
            <p:sp>
              <p:nvSpPr>
                <p:cNvPr id="11" name="TextBox 10">
                  <a:extLst>
                    <a:ext uri="{FF2B5EF4-FFF2-40B4-BE49-F238E27FC236}">
                      <a16:creationId xmlns:a16="http://schemas.microsoft.com/office/drawing/2014/main" id="{E05B28E0-9193-41E9-A5A5-99BAD87045EB}"/>
                    </a:ext>
                  </a:extLst>
                </p:cNvPr>
                <p:cNvSpPr txBox="1"/>
                <p:nvPr/>
              </p:nvSpPr>
              <p:spPr>
                <a:xfrm>
                  <a:off x="6508969" y="4183791"/>
                  <a:ext cx="1700315" cy="42171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solidFill>
                        <a:schemeClr val="accent4">
                          <a:lumMod val="75000"/>
                        </a:scheme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upported 1003 RNAs (p&lt;0.05) in the LMM (linear over time)</a:t>
                  </a:r>
                </a:p>
              </p:txBody>
            </p:sp>
          </p:grpSp>
        </p:grp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AB745236-8EF8-40E2-BBF0-15D3DD2EC38A}"/>
                </a:ext>
              </a:extLst>
            </p:cNvPr>
            <p:cNvSpPr txBox="1"/>
            <p:nvPr/>
          </p:nvSpPr>
          <p:spPr>
            <a:xfrm>
              <a:off x="7732298" y="7016029"/>
              <a:ext cx="286167" cy="6201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1</a:t>
              </a:r>
            </a:p>
            <a:p>
              <a:r>
                <a:rPr lang="en-US" sz="8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8</a:t>
              </a:r>
            </a:p>
            <a:p>
              <a:r>
                <a:rPr lang="en-US" sz="800" b="1" dirty="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3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47191DDB-F8AD-40D2-9316-8C4D1FF5A1B3}"/>
                </a:ext>
              </a:extLst>
            </p:cNvPr>
            <p:cNvSpPr txBox="1"/>
            <p:nvPr/>
          </p:nvSpPr>
          <p:spPr>
            <a:xfrm>
              <a:off x="5890954" y="7101084"/>
              <a:ext cx="388369" cy="6201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616</a:t>
              </a:r>
            </a:p>
            <a:p>
              <a:r>
                <a:rPr lang="en-US" sz="8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126</a:t>
              </a:r>
            </a:p>
            <a:p>
              <a:r>
                <a:rPr lang="en-US" sz="800" b="1" dirty="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90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34F667E3-8694-422B-93CA-16694FD95E49}"/>
                </a:ext>
              </a:extLst>
            </p:cNvPr>
            <p:cNvSpPr txBox="1"/>
            <p:nvPr/>
          </p:nvSpPr>
          <p:spPr>
            <a:xfrm>
              <a:off x="6804212" y="7289489"/>
              <a:ext cx="235066" cy="2894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A4D9DF97-9075-4C95-AE1F-3DDE480310A8}"/>
              </a:ext>
            </a:extLst>
          </p:cNvPr>
          <p:cNvSpPr txBox="1"/>
          <p:nvPr/>
        </p:nvSpPr>
        <p:spPr>
          <a:xfrm>
            <a:off x="0" y="6382378"/>
            <a:ext cx="6324193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  <a:r>
              <a:rPr lang="en-US" sz="10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Quantitative results for differentially expressed protein coding RNAs supported in DGE analysis between CR and AL in the LMM (between Baseline &amp; 12-month(12mo) and Baseline &amp; 24month(24mo) and linear assumption over time. (a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 Volcano plots depicting the results of differential gene expression analysis using LMM (at 12mo(left) and 24mo (right)). Each dot (read dot (positive beta) and blue dot (negative beta)) represents a gene (for top 20 genes in each group (beta positive and beta negative) were labeled with common name of gene). x-axis represents beta coefficient, y-axis represents -log10(p-value). 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mparison of differentially expressed RNAs (with p&lt;0.05) between CR and AL by the LMM models (linear time and at specific 12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24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1D53D9F4-E5EA-40BC-824D-52430EF50E8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144"/>
          <a:stretch/>
        </p:blipFill>
        <p:spPr>
          <a:xfrm>
            <a:off x="38836" y="306658"/>
            <a:ext cx="3247390" cy="3047859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7416D06A-0328-47FB-9147-08942181D6D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144"/>
          <a:stretch/>
        </p:blipFill>
        <p:spPr>
          <a:xfrm>
            <a:off x="3319540" y="412284"/>
            <a:ext cx="3049463" cy="2862093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8B8859D6-3CBC-49DB-A431-FC9D6F9C9162}"/>
              </a:ext>
            </a:extLst>
          </p:cNvPr>
          <p:cNvSpPr txBox="1"/>
          <p:nvPr/>
        </p:nvSpPr>
        <p:spPr>
          <a:xfrm>
            <a:off x="-56197" y="0"/>
            <a:ext cx="4069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927A519-79A0-4A90-B02D-7B4BFA995ABC}"/>
              </a:ext>
            </a:extLst>
          </p:cNvPr>
          <p:cNvSpPr txBox="1"/>
          <p:nvPr/>
        </p:nvSpPr>
        <p:spPr>
          <a:xfrm>
            <a:off x="550157" y="47556"/>
            <a:ext cx="22247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MM (between Baseline and 12mo)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F25BB91C-407A-4652-A32D-DD9DAC959B41}"/>
              </a:ext>
            </a:extLst>
          </p:cNvPr>
          <p:cNvSpPr txBox="1"/>
          <p:nvPr/>
        </p:nvSpPr>
        <p:spPr>
          <a:xfrm>
            <a:off x="1480000" y="3436398"/>
            <a:ext cx="4624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CE5366FF-D292-4D35-B543-C3767C99A8AA}"/>
              </a:ext>
            </a:extLst>
          </p:cNvPr>
          <p:cNvSpPr txBox="1"/>
          <p:nvPr/>
        </p:nvSpPr>
        <p:spPr>
          <a:xfrm>
            <a:off x="4063237" y="54245"/>
            <a:ext cx="22247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MM (between Baseline and 24mo)</a:t>
            </a:r>
          </a:p>
        </p:txBody>
      </p:sp>
    </p:spTree>
    <p:extLst>
      <p:ext uri="{BB962C8B-B14F-4D97-AF65-F5344CB8AC3E}">
        <p14:creationId xmlns:p14="http://schemas.microsoft.com/office/powerpoint/2010/main" val="24338241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" name="Picture 35" descr="Diagram&#10;&#10;Description automatically generated">
            <a:extLst>
              <a:ext uri="{FF2B5EF4-FFF2-40B4-BE49-F238E27FC236}">
                <a16:creationId xmlns:a16="http://schemas.microsoft.com/office/drawing/2014/main" id="{406F98DD-3C1F-B4FA-DDAF-E1D327FFB75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40"/>
          <a:stretch/>
        </p:blipFill>
        <p:spPr>
          <a:xfrm>
            <a:off x="0" y="141026"/>
            <a:ext cx="6400800" cy="7151340"/>
          </a:xfrm>
          <a:prstGeom prst="rect">
            <a:avLst/>
          </a:prstGeom>
        </p:spPr>
      </p:pic>
      <p:pic>
        <p:nvPicPr>
          <p:cNvPr id="38" name="Picture 37" descr="Chart, line chart&#10;&#10;Description automatically generated">
            <a:extLst>
              <a:ext uri="{FF2B5EF4-FFF2-40B4-BE49-F238E27FC236}">
                <a16:creationId xmlns:a16="http://schemas.microsoft.com/office/drawing/2014/main" id="{073ACC6B-7AC5-3AA0-F70C-091A206CC31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33" t="12271"/>
          <a:stretch/>
        </p:blipFill>
        <p:spPr>
          <a:xfrm>
            <a:off x="167640" y="7346796"/>
            <a:ext cx="2583183" cy="1163166"/>
          </a:xfrm>
          <a:prstGeom prst="rect">
            <a:avLst/>
          </a:prstGeom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id="{DF958925-505D-5865-8F53-59444A68AD60}"/>
              </a:ext>
            </a:extLst>
          </p:cNvPr>
          <p:cNvSpPr txBox="1"/>
          <p:nvPr/>
        </p:nvSpPr>
        <p:spPr>
          <a:xfrm>
            <a:off x="1" y="8394546"/>
            <a:ext cx="609600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: </a:t>
            </a:r>
            <a:r>
              <a:rPr lang="en-US" sz="10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iner smooth trajectories of supported differentially expressed all significant genes obtained through DGE analysis between CR and AL </a:t>
            </a:r>
            <a:r>
              <a:rPr lang="en-US" sz="10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in the LMM </a:t>
            </a:r>
            <a:r>
              <a:rPr lang="en-US" sz="10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linear over time) at p&lt;0.01 as discussed in Table 2. (a)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hown all genes with Beta&gt;0; 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hown all genes with Beta&lt;0.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2EE2D8D7-5817-4BB7-AE32-4D958026E18A}"/>
              </a:ext>
            </a:extLst>
          </p:cNvPr>
          <p:cNvSpPr txBox="1"/>
          <p:nvPr/>
        </p:nvSpPr>
        <p:spPr>
          <a:xfrm>
            <a:off x="-30083" y="7219904"/>
            <a:ext cx="4058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417566AC-5E7F-8626-1CBB-EDE3BB7F6D9B}"/>
              </a:ext>
            </a:extLst>
          </p:cNvPr>
          <p:cNvSpPr txBox="1"/>
          <p:nvPr/>
        </p:nvSpPr>
        <p:spPr>
          <a:xfrm>
            <a:off x="0" y="83820"/>
            <a:ext cx="3757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</p:spTree>
    <p:extLst>
      <p:ext uri="{BB962C8B-B14F-4D97-AF65-F5344CB8AC3E}">
        <p14:creationId xmlns:p14="http://schemas.microsoft.com/office/powerpoint/2010/main" val="30212547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TextBox 38">
            <a:extLst>
              <a:ext uri="{FF2B5EF4-FFF2-40B4-BE49-F238E27FC236}">
                <a16:creationId xmlns:a16="http://schemas.microsoft.com/office/drawing/2014/main" id="{DF958925-505D-5865-8F53-59444A68AD60}"/>
              </a:ext>
            </a:extLst>
          </p:cNvPr>
          <p:cNvSpPr txBox="1"/>
          <p:nvPr/>
        </p:nvSpPr>
        <p:spPr>
          <a:xfrm>
            <a:off x="220132" y="6574213"/>
            <a:ext cx="572346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: </a:t>
            </a:r>
            <a:r>
              <a:rPr lang="en-US" sz="10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earson correlation (r) and p-value calculated for between gene expressions (as listed in Table 2) and muscle strength variables (peak torque and average power in the isokinetic task at 60°.s</a:t>
            </a:r>
            <a:r>
              <a:rPr lang="en-US" sz="1000" b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-1</a:t>
            </a:r>
            <a:r>
              <a:rPr lang="en-US" sz="10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nd 180°.s</a:t>
            </a:r>
            <a:r>
              <a:rPr lang="en-US" sz="1000" b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-1</a:t>
            </a:r>
            <a:r>
              <a:rPr lang="en-US" sz="10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 at Baseline.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 descr="Table&#10;&#10;Description automatically generated">
            <a:extLst>
              <a:ext uri="{FF2B5EF4-FFF2-40B4-BE49-F238E27FC236}">
                <a16:creationId xmlns:a16="http://schemas.microsoft.com/office/drawing/2014/main" id="{BFEB2ECB-271A-1B49-0A4A-7C28C19EF92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38"/>
          <a:stretch/>
        </p:blipFill>
        <p:spPr>
          <a:xfrm>
            <a:off x="220132" y="219071"/>
            <a:ext cx="6180667" cy="62727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073823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TextBox 38">
            <a:extLst>
              <a:ext uri="{FF2B5EF4-FFF2-40B4-BE49-F238E27FC236}">
                <a16:creationId xmlns:a16="http://schemas.microsoft.com/office/drawing/2014/main" id="{DF958925-505D-5865-8F53-59444A68AD60}"/>
              </a:ext>
            </a:extLst>
          </p:cNvPr>
          <p:cNvSpPr txBox="1"/>
          <p:nvPr/>
        </p:nvSpPr>
        <p:spPr>
          <a:xfrm>
            <a:off x="129947" y="1729740"/>
            <a:ext cx="627085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: </a:t>
            </a:r>
            <a:r>
              <a:rPr lang="en-US" sz="10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iner smooth trajectories of supported differentially expressed significant genes obtained through DGE analysis between CR and AL </a:t>
            </a:r>
            <a:r>
              <a:rPr lang="en-US" sz="10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in the LMM </a:t>
            </a:r>
            <a:r>
              <a:rPr lang="en-US" sz="10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linear over time)  at 0.01&lt;p&lt;0.05 as discussed in the manuscript text.</a:t>
            </a:r>
            <a:endParaRPr lang="en-US" sz="1000" b="1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Picture 8" descr="Chart, scatter chart&#10;&#10;Description automatically generated">
            <a:extLst>
              <a:ext uri="{FF2B5EF4-FFF2-40B4-BE49-F238E27FC236}">
                <a16:creationId xmlns:a16="http://schemas.microsoft.com/office/drawing/2014/main" id="{4B38ABB6-9C8D-D06B-8744-F69B4C68804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20040"/>
            <a:ext cx="6400800" cy="132588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03D897A-191A-828D-6F0B-89B4479493C8}"/>
              </a:ext>
            </a:extLst>
          </p:cNvPr>
          <p:cNvSpPr txBox="1"/>
          <p:nvPr/>
        </p:nvSpPr>
        <p:spPr>
          <a:xfrm>
            <a:off x="0" y="6471832"/>
            <a:ext cx="6324193" cy="9738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274320" algn="just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: </a:t>
            </a:r>
            <a:r>
              <a:rPr lang="en-US" sz="1100" b="1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Quantification of shared transcripts that </a:t>
            </a: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ere </a:t>
            </a:r>
            <a:r>
              <a:rPr lang="en-US" sz="1100" b="1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orted differentially changes both in </a:t>
            </a:r>
            <a:r>
              <a:rPr lang="en-US" sz="1100" b="1" i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allisto</a:t>
            </a:r>
            <a:r>
              <a:rPr lang="en-US" sz="1100" b="1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RSEM approaches obtained through DTE (differential transcript expression) and/or  DTU (Differential transcript usage) </a:t>
            </a:r>
            <a:r>
              <a:rPr lang="en-US" sz="11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etween CR and AL </a:t>
            </a:r>
            <a:r>
              <a:rPr lang="en-US" sz="11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in the LMM </a:t>
            </a:r>
            <a:r>
              <a:rPr lang="en-US" sz="11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linear over time) </a:t>
            </a:r>
            <a:r>
              <a:rPr lang="en-US" sz="1100" b="1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t p&lt;0.01.</a:t>
            </a:r>
            <a:endParaRPr lang="en-US" sz="1100" b="1" i="1" dirty="0">
              <a:solidFill>
                <a:srgbClr val="44546A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766FD6B1-3843-37C9-2C80-B88CB91B5063}"/>
              </a:ext>
            </a:extLst>
          </p:cNvPr>
          <p:cNvGrpSpPr/>
          <p:nvPr/>
        </p:nvGrpSpPr>
        <p:grpSpPr>
          <a:xfrm>
            <a:off x="946830" y="3646639"/>
            <a:ext cx="3782156" cy="2658302"/>
            <a:chOff x="48353" y="1568528"/>
            <a:chExt cx="3718165" cy="2557771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7F22C0C2-D78F-4C58-14AB-18B2DC44C28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12157"/>
            <a:stretch/>
          </p:blipFill>
          <p:spPr>
            <a:xfrm>
              <a:off x="48353" y="1691640"/>
              <a:ext cx="3718165" cy="2434659"/>
            </a:xfrm>
            <a:prstGeom prst="ellipse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87E07396-37C1-CA52-1748-2DE5032CFBEB}"/>
                </a:ext>
              </a:extLst>
            </p:cNvPr>
            <p:cNvSpPr txBox="1"/>
            <p:nvPr/>
          </p:nvSpPr>
          <p:spPr>
            <a:xfrm>
              <a:off x="762000" y="1568529"/>
              <a:ext cx="74732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/>
                <a:t>Kallisto(DTU)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5F0A650B-C3B0-8B6E-2D18-104C3F4C3FB7}"/>
                </a:ext>
              </a:extLst>
            </p:cNvPr>
            <p:cNvSpPr txBox="1"/>
            <p:nvPr/>
          </p:nvSpPr>
          <p:spPr>
            <a:xfrm>
              <a:off x="2145730" y="1568528"/>
              <a:ext cx="65915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/>
                <a:t>RSEM(DTE)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9B4838B4-EFC0-D3A1-5518-2E5074179995}"/>
                </a:ext>
              </a:extLst>
            </p:cNvPr>
            <p:cNvSpPr txBox="1"/>
            <p:nvPr/>
          </p:nvSpPr>
          <p:spPr>
            <a:xfrm>
              <a:off x="116932" y="1852220"/>
              <a:ext cx="7296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/>
                <a:t>Kallisto(DTE)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5CDF36E9-E863-1F63-B0B0-2B5DD59ED0D3}"/>
                </a:ext>
              </a:extLst>
            </p:cNvPr>
            <p:cNvSpPr txBox="1"/>
            <p:nvPr/>
          </p:nvSpPr>
          <p:spPr>
            <a:xfrm>
              <a:off x="2907817" y="1852220"/>
              <a:ext cx="6767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/>
                <a:t>RSEM(DTU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2341345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TextBox 38">
            <a:extLst>
              <a:ext uri="{FF2B5EF4-FFF2-40B4-BE49-F238E27FC236}">
                <a16:creationId xmlns:a16="http://schemas.microsoft.com/office/drawing/2014/main" id="{DF958925-505D-5865-8F53-59444A68AD60}"/>
              </a:ext>
            </a:extLst>
          </p:cNvPr>
          <p:cNvSpPr txBox="1"/>
          <p:nvPr/>
        </p:nvSpPr>
        <p:spPr>
          <a:xfrm>
            <a:off x="38303" y="3670030"/>
            <a:ext cx="6324193" cy="6090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R="274320" algn="just">
              <a:lnSpc>
                <a:spcPct val="115000"/>
              </a:lnSpc>
              <a:spcAft>
                <a:spcPts val="1000"/>
              </a:spcAft>
            </a:pP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. </a:t>
            </a:r>
            <a:r>
              <a:rPr lang="en-US" sz="1000" b="1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ignificant splicing variants that were differentially changed by both in DTE and DTU analysis between CR and AL </a:t>
            </a:r>
            <a:r>
              <a:rPr lang="en-US" sz="10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in the LMM </a:t>
            </a:r>
            <a:r>
              <a:rPr lang="en-US" sz="1000" b="1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liner over time) at p&lt;0.01 transcribed from genes that did not find significant (p&gt;0.05) in DGE analysis.</a:t>
            </a:r>
            <a:endParaRPr lang="en-US" sz="1000" b="1" i="1" dirty="0">
              <a:solidFill>
                <a:srgbClr val="44546A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9" name="Picture 8" descr="A picture containing box and whisker chart&#10;&#10;Description automatically generated">
            <a:extLst>
              <a:ext uri="{FF2B5EF4-FFF2-40B4-BE49-F238E27FC236}">
                <a16:creationId xmlns:a16="http://schemas.microsoft.com/office/drawing/2014/main" id="{A0A3236C-1B1C-B5E7-BFE5-61EA6A97E87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38304" y="0"/>
            <a:ext cx="6400800" cy="35072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844936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2696</TotalTime>
  <Words>526</Words>
  <Application>Microsoft Office PowerPoint</Application>
  <PresentationFormat>Custom</PresentationFormat>
  <Paragraphs>39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s, Jayanta (NIH/NIA/IRP) [F]</dc:creator>
  <cp:lastModifiedBy>Das, Jayanta (NIH/NIA/IRP) [F]</cp:lastModifiedBy>
  <cp:revision>1001</cp:revision>
  <cp:lastPrinted>2022-05-26T18:27:07Z</cp:lastPrinted>
  <dcterms:created xsi:type="dcterms:W3CDTF">2021-09-16T13:14:16Z</dcterms:created>
  <dcterms:modified xsi:type="dcterms:W3CDTF">2023-08-16T16:51:55Z</dcterms:modified>
</cp:coreProperties>
</file>